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5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2" d="100"/>
          <a:sy n="72" d="100"/>
        </p:scale>
        <p:origin x="-104" y="-4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43D363C-A0B1-40F6-947B-D1F6D4E87BFF}" type="datetimeFigureOut">
              <a:rPr kumimoji="1" lang="ja-JP" altLang="en-US" smtClean="0"/>
              <a:pPr/>
              <a:t>16/08/09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B2DCE09-1CB5-4BBF-9776-9713A11432E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43180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E0E2107-2E73-4543-824F-46DD92997D51}" type="slidenum">
              <a:rPr kumimoji="1" lang="ja-JP" altLang="en-US" smtClean="0"/>
              <a:pPr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635321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 サブタイトルの書式設定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ABDD0-55AC-4C61-B947-AF801E5E7973}" type="datetimeFigureOut">
              <a:rPr kumimoji="1" lang="ja-JP" altLang="en-US" smtClean="0"/>
              <a:pPr/>
              <a:t>16/08/09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20785-5D96-4D0D-B151-A89924C338E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ABDD0-55AC-4C61-B947-AF801E5E7973}" type="datetimeFigureOut">
              <a:rPr kumimoji="1" lang="ja-JP" altLang="en-US" smtClean="0"/>
              <a:pPr/>
              <a:t>16/08/09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20785-5D96-4D0D-B151-A89924C338E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ABDD0-55AC-4C61-B947-AF801E5E7973}" type="datetimeFigureOut">
              <a:rPr kumimoji="1" lang="ja-JP" altLang="en-US" smtClean="0"/>
              <a:pPr/>
              <a:t>16/08/09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20785-5D96-4D0D-B151-A89924C338E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ABDD0-55AC-4C61-B947-AF801E5E7973}" type="datetimeFigureOut">
              <a:rPr kumimoji="1" lang="ja-JP" altLang="en-US" smtClean="0"/>
              <a:pPr/>
              <a:t>16/08/09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20785-5D96-4D0D-B151-A89924C338E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ABDD0-55AC-4C61-B947-AF801E5E7973}" type="datetimeFigureOut">
              <a:rPr kumimoji="1" lang="ja-JP" altLang="en-US" smtClean="0"/>
              <a:pPr/>
              <a:t>16/08/09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20785-5D96-4D0D-B151-A89924C338E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ABDD0-55AC-4C61-B947-AF801E5E7973}" type="datetimeFigureOut">
              <a:rPr kumimoji="1" lang="ja-JP" altLang="en-US" smtClean="0"/>
              <a:pPr/>
              <a:t>16/08/09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20785-5D96-4D0D-B151-A89924C338E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ABDD0-55AC-4C61-B947-AF801E5E7973}" type="datetimeFigureOut">
              <a:rPr kumimoji="1" lang="ja-JP" altLang="en-US" smtClean="0"/>
              <a:pPr/>
              <a:t>16/08/09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20785-5D96-4D0D-B151-A89924C338E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ABDD0-55AC-4C61-B947-AF801E5E7973}" type="datetimeFigureOut">
              <a:rPr kumimoji="1" lang="ja-JP" altLang="en-US" smtClean="0"/>
              <a:pPr/>
              <a:t>16/08/09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20785-5D96-4D0D-B151-A89924C338E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ABDD0-55AC-4C61-B947-AF801E5E7973}" type="datetimeFigureOut">
              <a:rPr kumimoji="1" lang="ja-JP" altLang="en-US" smtClean="0"/>
              <a:pPr/>
              <a:t>16/08/09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20785-5D96-4D0D-B151-A89924C338E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ABDD0-55AC-4C61-B947-AF801E5E7973}" type="datetimeFigureOut">
              <a:rPr kumimoji="1" lang="ja-JP" altLang="en-US" smtClean="0"/>
              <a:pPr/>
              <a:t>16/08/09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20785-5D96-4D0D-B151-A89924C338E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94ABDD0-55AC-4C61-B947-AF801E5E7973}" type="datetimeFigureOut">
              <a:rPr kumimoji="1" lang="ja-JP" altLang="en-US" smtClean="0"/>
              <a:pPr/>
              <a:t>16/08/09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8920785-5D96-4D0D-B151-A89924C338E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 タイトルの書式設定</a:t>
            </a:r>
            <a:endParaRPr kumimoji="1"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4ABDD0-55AC-4C61-B947-AF801E5E7973}" type="datetimeFigureOut">
              <a:rPr kumimoji="1" lang="ja-JP" altLang="en-US" smtClean="0"/>
              <a:pPr/>
              <a:t>16/08/09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920785-5D96-4D0D-B151-A89924C338EC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7544" y="0"/>
            <a:ext cx="7992888" cy="68505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" name="テキスト ボックス 2"/>
          <p:cNvSpPr txBox="1"/>
          <p:nvPr/>
        </p:nvSpPr>
        <p:spPr>
          <a:xfrm>
            <a:off x="3560614" y="4676000"/>
            <a:ext cx="42351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700" b="1" dirty="0" smtClean="0"/>
              <a:t>Hyogo</a:t>
            </a:r>
            <a:endParaRPr kumimoji="1" lang="ja-JP" altLang="en-US" sz="700" b="1" dirty="0"/>
          </a:p>
        </p:txBody>
      </p:sp>
      <p:sp>
        <p:nvSpPr>
          <p:cNvPr id="4" name="テキスト ボックス 3"/>
          <p:cNvSpPr txBox="1"/>
          <p:nvPr/>
        </p:nvSpPr>
        <p:spPr>
          <a:xfrm>
            <a:off x="3180771" y="4674524"/>
            <a:ext cx="54053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 smtClean="0"/>
              <a:t>Okayama</a:t>
            </a:r>
            <a:endParaRPr kumimoji="1" lang="ja-JP" altLang="en-US" sz="700" b="1" dirty="0"/>
          </a:p>
        </p:txBody>
      </p:sp>
      <p:sp>
        <p:nvSpPr>
          <p:cNvPr id="5" name="テキスト ボックス 4"/>
          <p:cNvSpPr txBox="1"/>
          <p:nvPr/>
        </p:nvSpPr>
        <p:spPr>
          <a:xfrm>
            <a:off x="2581153" y="4475945"/>
            <a:ext cx="508473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 smtClean="0"/>
              <a:t>Shimane</a:t>
            </a:r>
            <a:endParaRPr kumimoji="1" lang="ja-JP" altLang="en-US" sz="700" b="1" dirty="0"/>
          </a:p>
        </p:txBody>
      </p:sp>
      <p:sp>
        <p:nvSpPr>
          <p:cNvPr id="6" name="テキスト ボックス 5"/>
          <p:cNvSpPr txBox="1"/>
          <p:nvPr/>
        </p:nvSpPr>
        <p:spPr>
          <a:xfrm>
            <a:off x="2750502" y="4832503"/>
            <a:ext cx="56778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 smtClean="0"/>
              <a:t>Hiroshima</a:t>
            </a:r>
            <a:endParaRPr kumimoji="1" lang="ja-JP" altLang="en-US" sz="700" b="1" dirty="0"/>
          </a:p>
        </p:txBody>
      </p:sp>
      <p:sp>
        <p:nvSpPr>
          <p:cNvPr id="7" name="テキスト ボックス 6"/>
          <p:cNvSpPr txBox="1"/>
          <p:nvPr/>
        </p:nvSpPr>
        <p:spPr>
          <a:xfrm>
            <a:off x="2309033" y="4935888"/>
            <a:ext cx="59343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 smtClean="0"/>
              <a:t>Yamaguchi</a:t>
            </a:r>
            <a:endParaRPr kumimoji="1" lang="ja-JP" altLang="en-US" sz="700" b="1" dirty="0"/>
          </a:p>
        </p:txBody>
      </p:sp>
      <p:sp>
        <p:nvSpPr>
          <p:cNvPr id="8" name="テキスト ボックス 7"/>
          <p:cNvSpPr txBox="1"/>
          <p:nvPr/>
        </p:nvSpPr>
        <p:spPr>
          <a:xfrm>
            <a:off x="3837372" y="5371393"/>
            <a:ext cx="606256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 smtClean="0"/>
              <a:t>Wakayama</a:t>
            </a:r>
            <a:endParaRPr kumimoji="1" lang="ja-JP" altLang="en-US" sz="700" b="1" dirty="0"/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3390696" y="5114914"/>
            <a:ext cx="59343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 smtClean="0"/>
              <a:t>Tokushima</a:t>
            </a:r>
            <a:endParaRPr kumimoji="1" lang="ja-JP" altLang="en-US" sz="700" b="1" dirty="0"/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3132582" y="5213298"/>
            <a:ext cx="38985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 smtClean="0"/>
              <a:t>Kochi</a:t>
            </a:r>
            <a:endParaRPr kumimoji="1" lang="ja-JP" altLang="en-US" sz="700" b="1" dirty="0"/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2858437" y="5261473"/>
            <a:ext cx="417102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 smtClean="0"/>
              <a:t>Ehime</a:t>
            </a:r>
            <a:endParaRPr kumimoji="1" lang="ja-JP" altLang="en-US" sz="700" b="1" dirty="0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2315942" y="5336932"/>
            <a:ext cx="34336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 smtClean="0"/>
              <a:t>Oita</a:t>
            </a:r>
            <a:endParaRPr kumimoji="1" lang="ja-JP" altLang="en-US" sz="700" b="1" dirty="0"/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1908891" y="5330676"/>
            <a:ext cx="3593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 smtClean="0"/>
              <a:t>Saga</a:t>
            </a:r>
            <a:endParaRPr kumimoji="1" lang="ja-JP" altLang="en-US" sz="700" b="1" dirty="0"/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2149503" y="5482040"/>
            <a:ext cx="4732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 smtClean="0"/>
              <a:t>Kuma</a:t>
            </a:r>
          </a:p>
          <a:p>
            <a:r>
              <a:rPr lang="en-US" altLang="ja-JP" sz="700" b="1" dirty="0" smtClean="0"/>
              <a:t>   -moto</a:t>
            </a:r>
            <a:endParaRPr kumimoji="1" lang="ja-JP" altLang="en-US" sz="700" b="1" dirty="0"/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2612888" y="5904362"/>
            <a:ext cx="51969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 smtClean="0"/>
              <a:t>Miyazaki</a:t>
            </a: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1791071" y="6325288"/>
            <a:ext cx="595035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 smtClean="0"/>
              <a:t>Kagoshima</a:t>
            </a: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1460689" y="5638584"/>
            <a:ext cx="52290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700" b="1" dirty="0" smtClean="0"/>
              <a:t>Nagasaki</a:t>
            </a: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323528" y="251356"/>
            <a:ext cx="23145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>
                <a:solidFill>
                  <a:prstClr val="black">
                    <a:lumMod val="65000"/>
                    <a:lumOff val="35000"/>
                  </a:prstClr>
                </a:solidFill>
                <a:latin typeface="Arial"/>
                <a:cs typeface="Arial"/>
              </a:rPr>
              <a:t>Supplementary Fig1. </a:t>
            </a:r>
            <a:endParaRPr kumimoji="1" lang="ja-JP" altLang="en-US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99511728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</TotalTime>
  <Words>22</Words>
  <Application>Microsoft Macintosh PowerPoint</Application>
  <PresentationFormat>画面に合わせる (4:3)</PresentationFormat>
  <Paragraphs>18</Paragraphs>
  <Slides>1</Slides>
  <Notes>1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Hirofumi Kato</dc:creator>
  <cp:lastModifiedBy>大石 和徳</cp:lastModifiedBy>
  <cp:revision>17</cp:revision>
  <dcterms:created xsi:type="dcterms:W3CDTF">2016-03-19T10:58:12Z</dcterms:created>
  <dcterms:modified xsi:type="dcterms:W3CDTF">2016-08-09T08:51:38Z</dcterms:modified>
</cp:coreProperties>
</file>